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75" d="100"/>
          <a:sy n="75" d="100"/>
        </p:scale>
        <p:origin x="139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23142A-F1F4-47F0-9382-19A3BDC3974B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122BF9-A513-4AEE-8B81-FD88A489C8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7407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0D74E7-2E61-46C2-BC27-875AE98B6E6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8460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574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990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641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747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027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5133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730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659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1673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573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653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93FB6-5187-4BB4-B180-659055F31DEF}" type="datetimeFigureOut">
              <a:rPr kumimoji="1" lang="ja-JP" altLang="en-US" smtClean="0"/>
              <a:t>2020/10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D754C-C45E-4552-B7BE-9B54CB13D3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627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18" Type="http://schemas.openxmlformats.org/officeDocument/2006/relationships/image" Target="../media/image9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17" Type="http://schemas.microsoft.com/office/2007/relationships/hdphoto" Target="../media/hdphoto7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85008" y="1190909"/>
            <a:ext cx="21178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Information.</a:t>
            </a:r>
          </a:p>
          <a:p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532904" y="1821851"/>
            <a:ext cx="460762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dirty="0">
                <a:solidFill>
                  <a:srgbClr val="333333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bject: </a:t>
            </a:r>
            <a:r>
              <a:rPr lang="en-US" altLang="ja-JP" sz="1400" dirty="0">
                <a:solidFill>
                  <a:srgbClr val="222222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Ref: Submission ID eb760f50-1d9d-4332-9054-1c944d3073b3</a:t>
            </a:r>
            <a:endParaRPr lang="ja-JP" altLang="ja-JP" sz="1400" dirty="0">
              <a:solidFill>
                <a:srgbClr val="333333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532904" y="3543910"/>
            <a:ext cx="561257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dirty="0">
                <a:solidFill>
                  <a:srgbClr val="333333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itle: “Bidirectional, non-necrotizing glomerular crescents are the critical pathology in X-linked Alport Syndrome mouse model harboring nonsense mutation of human </a:t>
            </a:r>
            <a:r>
              <a:rPr lang="en-US" altLang="ja-JP" sz="1400" i="1" dirty="0">
                <a:solidFill>
                  <a:srgbClr val="333333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OL4A5</a:t>
            </a:r>
            <a:r>
              <a:rPr lang="en-US" altLang="ja-JP" sz="1400" dirty="0">
                <a:solidFill>
                  <a:srgbClr val="333333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”</a:t>
            </a:r>
            <a:endParaRPr lang="ja-JP" altLang="ja-JP" sz="1400" dirty="0">
              <a:solidFill>
                <a:srgbClr val="333333"/>
              </a:solidFill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532904" y="2468182"/>
            <a:ext cx="561257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uthor: Jiang Ying Song MD, PhD, Nobuyuki Saga MD, Kunio Kawanishi MD, PhD,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entaro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Hashikami, Michiyasu Takeyama PhD, Michio Nagata MD, PhD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B7F7B671-AD96-435D-9812-13CBA650A97B}"/>
              </a:ext>
            </a:extLst>
          </p:cNvPr>
          <p:cNvCxnSpPr>
            <a:cxnSpLocks/>
          </p:cNvCxnSpPr>
          <p:nvPr/>
        </p:nvCxnSpPr>
        <p:spPr>
          <a:xfrm>
            <a:off x="6722966" y="12872308"/>
            <a:ext cx="359353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F15D1EE9-C90C-4E6E-8954-B7BA3AF916B6}"/>
              </a:ext>
            </a:extLst>
          </p:cNvPr>
          <p:cNvCxnSpPr>
            <a:cxnSpLocks/>
          </p:cNvCxnSpPr>
          <p:nvPr/>
        </p:nvCxnSpPr>
        <p:spPr>
          <a:xfrm>
            <a:off x="12202052" y="12860878"/>
            <a:ext cx="957852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3"/>
          <p:cNvSpPr>
            <a:spLocks noChangeArrowheads="1"/>
          </p:cNvSpPr>
          <p:nvPr/>
        </p:nvSpPr>
        <p:spPr bwMode="auto">
          <a:xfrm>
            <a:off x="558140" y="4561708"/>
            <a:ext cx="6832764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1" name="Rectangle 4"/>
          <p:cNvSpPr>
            <a:spLocks noChangeArrowheads="1"/>
          </p:cNvSpPr>
          <p:nvPr/>
        </p:nvSpPr>
        <p:spPr bwMode="auto">
          <a:xfrm>
            <a:off x="558140" y="5018908"/>
            <a:ext cx="5913912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1. Kidney of wild type mice showed no distinct abnormalities.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equential histology with Masson trichrome staining revealed well preserved glomeruli and </a:t>
            </a:r>
            <a:r>
              <a:rPr kumimoji="0" lang="en-US" altLang="ja-JP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ubulointerstitial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tment in 6, 13, 24, 30W in wild type mice (A-H). Ultrastructure revealed no apparent abnormalities in GBM, even in the late stage of 24W and 30W (I, J). Scale bar, 20 mm (A-H) and 5 mm (I, J).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8187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626368" y="5275350"/>
            <a:ext cx="2864085" cy="2840869"/>
          </a:xfrm>
          <a:prstGeom prst="rect">
            <a:avLst/>
          </a:prstGeom>
        </p:spPr>
      </p:pic>
      <p:pic>
        <p:nvPicPr>
          <p:cNvPr id="11" name="Picture 10" descr="A close up of a pizza&#10;&#10;Description automatically generated">
            <a:extLst>
              <a:ext uri="{FF2B5EF4-FFF2-40B4-BE49-F238E27FC236}">
                <a16:creationId xmlns:a16="http://schemas.microsoft.com/office/drawing/2014/main" id="{F1780B3E-5366-D74D-ABB5-8A8AAD75DAA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758" r="21248"/>
          <a:stretch/>
        </p:blipFill>
        <p:spPr>
          <a:xfrm>
            <a:off x="4944333" y="3324631"/>
            <a:ext cx="1386908" cy="1543050"/>
          </a:xfrm>
          <a:prstGeom prst="rect">
            <a:avLst/>
          </a:prstGeom>
        </p:spPr>
      </p:pic>
      <p:pic>
        <p:nvPicPr>
          <p:cNvPr id="9" name="Picture 8" descr="A picture containing food, pizza, sitting, covered&#10;&#10;Description automatically generated">
            <a:extLst>
              <a:ext uri="{FF2B5EF4-FFF2-40B4-BE49-F238E27FC236}">
                <a16:creationId xmlns:a16="http://schemas.microsoft.com/office/drawing/2014/main" id="{BF1948E5-4A06-BA41-B83A-D0C35E4A9D0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60" t="2978" r="50258" b="11434"/>
          <a:stretch/>
        </p:blipFill>
        <p:spPr>
          <a:xfrm>
            <a:off x="4944001" y="939487"/>
            <a:ext cx="1387571" cy="2069078"/>
          </a:xfrm>
          <a:prstGeom prst="rect">
            <a:avLst/>
          </a:prstGeom>
        </p:spPr>
      </p:pic>
      <p:pic>
        <p:nvPicPr>
          <p:cNvPr id="5" name="Picture 4" descr="A close up of a pizza&#10;&#10;Description automatically generated">
            <a:extLst>
              <a:ext uri="{FF2B5EF4-FFF2-40B4-BE49-F238E27FC236}">
                <a16:creationId xmlns:a16="http://schemas.microsoft.com/office/drawing/2014/main" id="{2502A818-AB2C-EE49-B106-D2118242AFB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32" r="12973"/>
          <a:stretch/>
        </p:blipFill>
        <p:spPr>
          <a:xfrm>
            <a:off x="3502902" y="3324631"/>
            <a:ext cx="1386908" cy="1543050"/>
          </a:xfrm>
          <a:prstGeom prst="rect">
            <a:avLst/>
          </a:prstGeom>
        </p:spPr>
      </p:pic>
      <p:pic>
        <p:nvPicPr>
          <p:cNvPr id="16" name="Picture 15" descr="A picture containing table, food, close, pizza&#10;&#10;Description automatically generated">
            <a:extLst>
              <a:ext uri="{FF2B5EF4-FFF2-40B4-BE49-F238E27FC236}">
                <a16:creationId xmlns:a16="http://schemas.microsoft.com/office/drawing/2014/main" id="{722203DA-D72D-C44D-B6E3-3F133AF195F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425" r="14434"/>
          <a:stretch/>
        </p:blipFill>
        <p:spPr>
          <a:xfrm>
            <a:off x="2058410" y="3324631"/>
            <a:ext cx="1389970" cy="1543050"/>
          </a:xfrm>
          <a:prstGeom prst="rect">
            <a:avLst/>
          </a:prstGeom>
        </p:spPr>
      </p:pic>
      <p:pic>
        <p:nvPicPr>
          <p:cNvPr id="12" name="Picture 11" descr="A picture containing table, sitting, close, cake&#10;&#10;Description automatically generated">
            <a:extLst>
              <a:ext uri="{FF2B5EF4-FFF2-40B4-BE49-F238E27FC236}">
                <a16:creationId xmlns:a16="http://schemas.microsoft.com/office/drawing/2014/main" id="{83D8ECA5-515A-4D48-A56C-598856E2DC60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88" r="19417"/>
          <a:stretch/>
        </p:blipFill>
        <p:spPr>
          <a:xfrm>
            <a:off x="616980" y="3324631"/>
            <a:ext cx="1386908" cy="1543050"/>
          </a:xfrm>
          <a:prstGeom prst="rect">
            <a:avLst/>
          </a:prstGeom>
        </p:spPr>
      </p:pic>
      <p:pic>
        <p:nvPicPr>
          <p:cNvPr id="58" name="Picture 57" descr="A close up of a fabric surface&#10;&#10;Description automatically generated">
            <a:extLst>
              <a:ext uri="{FF2B5EF4-FFF2-40B4-BE49-F238E27FC236}">
                <a16:creationId xmlns:a16="http://schemas.microsoft.com/office/drawing/2014/main" id="{41B67F8B-27D8-0147-822B-DA67464B6D49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24" r="37700" b="14440"/>
          <a:stretch/>
        </p:blipFill>
        <p:spPr>
          <a:xfrm>
            <a:off x="3501180" y="939487"/>
            <a:ext cx="1388328" cy="2069824"/>
          </a:xfrm>
          <a:prstGeom prst="rect">
            <a:avLst/>
          </a:prstGeom>
        </p:spPr>
      </p:pic>
      <p:pic>
        <p:nvPicPr>
          <p:cNvPr id="14" name="Picture 13" descr="A close up of a sign&#10;&#10;Description automatically generated">
            <a:extLst>
              <a:ext uri="{FF2B5EF4-FFF2-40B4-BE49-F238E27FC236}">
                <a16:creationId xmlns:a16="http://schemas.microsoft.com/office/drawing/2014/main" id="{5F51F789-8AF5-2348-866C-7FA89675D291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17" t="661" r="28506" b="13884"/>
          <a:stretch/>
        </p:blipFill>
        <p:spPr>
          <a:xfrm>
            <a:off x="2059301" y="939487"/>
            <a:ext cx="1387385" cy="2065832"/>
          </a:xfrm>
          <a:prstGeom prst="rect">
            <a:avLst/>
          </a:prstGeom>
        </p:spPr>
      </p:pic>
      <p:pic>
        <p:nvPicPr>
          <p:cNvPr id="4" name="Picture 3" descr="A picture containing fruit, food, covered, table&#10;&#10;Description automatically generated">
            <a:extLst>
              <a:ext uri="{FF2B5EF4-FFF2-40B4-BE49-F238E27FC236}">
                <a16:creationId xmlns:a16="http://schemas.microsoft.com/office/drawing/2014/main" id="{2321BBE7-1AA2-0F49-850F-499A3F2518BF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231" r="27309" b="15292"/>
          <a:stretch/>
        </p:blipFill>
        <p:spPr>
          <a:xfrm>
            <a:off x="616062" y="939487"/>
            <a:ext cx="1388745" cy="206513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A953A3F-693E-4362-99B5-4F9156021D21}"/>
              </a:ext>
            </a:extLst>
          </p:cNvPr>
          <p:cNvSpPr txBox="1"/>
          <p:nvPr/>
        </p:nvSpPr>
        <p:spPr>
          <a:xfrm>
            <a:off x="227518" y="499795"/>
            <a:ext cx="2165832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25" dirty="0"/>
              <a:t>Supplemental Fig. 1</a:t>
            </a:r>
            <a:endParaRPr lang="ja-JP" altLang="en-US" sz="2025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894758" y="3055496"/>
            <a:ext cx="8313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6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2357868" y="3055496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14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3793501" y="3055496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22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5240810" y="3055496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30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894758" y="4965388"/>
            <a:ext cx="8313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6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2357868" y="4965388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14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1767121" y="8233133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22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5240810" y="4965388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30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8" name="Group 197">
            <a:extLst>
              <a:ext uri="{FF2B5EF4-FFF2-40B4-BE49-F238E27FC236}">
                <a16:creationId xmlns:a16="http://schemas.microsoft.com/office/drawing/2014/main" id="{44769BF5-A654-014C-A0F2-060F20643E44}"/>
              </a:ext>
            </a:extLst>
          </p:cNvPr>
          <p:cNvGrpSpPr/>
          <p:nvPr/>
        </p:nvGrpSpPr>
        <p:grpSpPr>
          <a:xfrm>
            <a:off x="615629" y="4502758"/>
            <a:ext cx="5626194" cy="447381"/>
            <a:chOff x="1107704" y="7351289"/>
            <a:chExt cx="10002123" cy="762151"/>
          </a:xfrm>
        </p:grpSpPr>
        <p:sp>
          <p:nvSpPr>
            <p:cNvPr id="215" name="テキスト ボックス 214"/>
            <p:cNvSpPr txBox="1"/>
            <p:nvPr/>
          </p:nvSpPr>
          <p:spPr>
            <a:xfrm>
              <a:off x="1107704" y="7366279"/>
              <a:ext cx="477079" cy="747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250" b="1" dirty="0"/>
                <a:t>E</a:t>
              </a:r>
              <a:endParaRPr lang="ja-JP" altLang="en-US" sz="2250" b="1" dirty="0"/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8782668" y="7351289"/>
              <a:ext cx="481788" cy="747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250" b="1" dirty="0"/>
                <a:t>H</a:t>
              </a:r>
              <a:endParaRPr lang="ja-JP" altLang="en-US" sz="2250" b="1" dirty="0"/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>
              <a:off x="6210316" y="7351289"/>
              <a:ext cx="448455" cy="747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250" b="1" dirty="0"/>
                <a:t>G</a:t>
              </a:r>
              <a:endParaRPr lang="ja-JP" altLang="en-US" sz="2250" b="1" dirty="0"/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3647919" y="7351289"/>
              <a:ext cx="425237" cy="747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250" b="1" dirty="0"/>
                <a:t>F</a:t>
              </a:r>
              <a:endParaRPr lang="ja-JP" altLang="en-US" sz="2250" b="1" dirty="0"/>
            </a:p>
          </p:txBody>
        </p: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1E5E1318-37F7-4C59-BD4E-9E500846AF18}"/>
                </a:ext>
              </a:extLst>
            </p:cNvPr>
            <p:cNvCxnSpPr>
              <a:cxnSpLocks/>
            </p:cNvCxnSpPr>
            <p:nvPr/>
          </p:nvCxnSpPr>
          <p:spPr>
            <a:xfrm>
              <a:off x="2479306" y="7801171"/>
              <a:ext cx="881734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1E5E1318-37F7-4C59-BD4E-9E500846AF18}"/>
                </a:ext>
              </a:extLst>
            </p:cNvPr>
            <p:cNvCxnSpPr>
              <a:cxnSpLocks/>
            </p:cNvCxnSpPr>
            <p:nvPr/>
          </p:nvCxnSpPr>
          <p:spPr>
            <a:xfrm>
              <a:off x="5062866" y="7801171"/>
              <a:ext cx="881734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1E5E1318-37F7-4C59-BD4E-9E500846AF18}"/>
                </a:ext>
              </a:extLst>
            </p:cNvPr>
            <p:cNvCxnSpPr>
              <a:cxnSpLocks/>
            </p:cNvCxnSpPr>
            <p:nvPr/>
          </p:nvCxnSpPr>
          <p:spPr>
            <a:xfrm>
              <a:off x="7631436" y="7801171"/>
              <a:ext cx="881734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1E5E1318-37F7-4C59-BD4E-9E500846AF18}"/>
                </a:ext>
              </a:extLst>
            </p:cNvPr>
            <p:cNvCxnSpPr>
              <a:cxnSpLocks/>
            </p:cNvCxnSpPr>
            <p:nvPr/>
          </p:nvCxnSpPr>
          <p:spPr>
            <a:xfrm>
              <a:off x="10228093" y="7801171"/>
              <a:ext cx="881734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9" name="テキスト ボックス 208"/>
          <p:cNvSpPr txBox="1"/>
          <p:nvPr/>
        </p:nvSpPr>
        <p:spPr>
          <a:xfrm>
            <a:off x="615629" y="2664733"/>
            <a:ext cx="275812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250" b="1" dirty="0"/>
              <a:t>A</a:t>
            </a:r>
            <a:endParaRPr lang="ja-JP" altLang="en-US" sz="2250" b="1" dirty="0"/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3507306" y="2664733"/>
            <a:ext cx="275812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250" b="1" dirty="0"/>
              <a:t>C</a:t>
            </a:r>
            <a:endParaRPr lang="ja-JP" altLang="en-US" sz="2250" b="1" dirty="0"/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2058758" y="2664733"/>
            <a:ext cx="275812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250" b="1" dirty="0"/>
              <a:t>B</a:t>
            </a:r>
            <a:endParaRPr lang="ja-JP" altLang="en-US" sz="2250" b="1" dirty="0"/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1E5E1318-37F7-4C59-BD4E-9E500846AF18}"/>
              </a:ext>
            </a:extLst>
          </p:cNvPr>
          <p:cNvCxnSpPr>
            <a:cxnSpLocks/>
          </p:cNvCxnSpPr>
          <p:nvPr/>
        </p:nvCxnSpPr>
        <p:spPr>
          <a:xfrm>
            <a:off x="1714832" y="2928485"/>
            <a:ext cx="183923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1E5E1318-37F7-4C59-BD4E-9E500846AF18}"/>
              </a:ext>
            </a:extLst>
          </p:cNvPr>
          <p:cNvCxnSpPr>
            <a:cxnSpLocks/>
          </p:cNvCxnSpPr>
          <p:nvPr/>
        </p:nvCxnSpPr>
        <p:spPr>
          <a:xfrm>
            <a:off x="3145629" y="2928486"/>
            <a:ext cx="187785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1E5E1318-37F7-4C59-BD4E-9E500846AF18}"/>
              </a:ext>
            </a:extLst>
          </p:cNvPr>
          <p:cNvCxnSpPr>
            <a:cxnSpLocks/>
          </p:cNvCxnSpPr>
          <p:nvPr/>
        </p:nvCxnSpPr>
        <p:spPr>
          <a:xfrm>
            <a:off x="4616395" y="2928486"/>
            <a:ext cx="17711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1E5E1318-37F7-4C59-BD4E-9E500846AF18}"/>
              </a:ext>
            </a:extLst>
          </p:cNvPr>
          <p:cNvCxnSpPr>
            <a:cxnSpLocks/>
          </p:cNvCxnSpPr>
          <p:nvPr/>
        </p:nvCxnSpPr>
        <p:spPr>
          <a:xfrm>
            <a:off x="6096233" y="2928486"/>
            <a:ext cx="153076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/>
          <p:cNvSpPr txBox="1"/>
          <p:nvPr/>
        </p:nvSpPr>
        <p:spPr>
          <a:xfrm>
            <a:off x="4956259" y="2664733"/>
            <a:ext cx="275812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250" b="1" dirty="0"/>
              <a:t>D</a:t>
            </a:r>
            <a:endParaRPr lang="ja-JP" altLang="en-US" sz="2250" b="1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291" y="5270844"/>
            <a:ext cx="2823935" cy="2856983"/>
          </a:xfrm>
          <a:prstGeom prst="rect">
            <a:avLst/>
          </a:prstGeom>
        </p:spPr>
      </p:pic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2D803FE0-358F-4B95-A5E4-A384888D3E67}"/>
              </a:ext>
            </a:extLst>
          </p:cNvPr>
          <p:cNvCxnSpPr>
            <a:cxnSpLocks/>
          </p:cNvCxnSpPr>
          <p:nvPr/>
        </p:nvCxnSpPr>
        <p:spPr>
          <a:xfrm>
            <a:off x="5579579" y="8000857"/>
            <a:ext cx="692092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2D803FE0-358F-4B95-A5E4-A384888D3E67}"/>
              </a:ext>
            </a:extLst>
          </p:cNvPr>
          <p:cNvCxnSpPr>
            <a:cxnSpLocks/>
          </p:cNvCxnSpPr>
          <p:nvPr/>
        </p:nvCxnSpPr>
        <p:spPr>
          <a:xfrm>
            <a:off x="2572556" y="8000857"/>
            <a:ext cx="68816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4616395" y="8233133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30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D78D108-B692-43F6-A1BE-470EF1805662}"/>
              </a:ext>
            </a:extLst>
          </p:cNvPr>
          <p:cNvSpPr txBox="1"/>
          <p:nvPr/>
        </p:nvSpPr>
        <p:spPr>
          <a:xfrm>
            <a:off x="3879226" y="5051113"/>
            <a:ext cx="793953" cy="24820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22w WT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-1766680" y="1901687"/>
            <a:ext cx="21672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13" dirty="0"/>
              <a:t>I</a:t>
            </a:r>
            <a:endParaRPr lang="ja-JP" altLang="en-US" sz="1013" dirty="0"/>
          </a:p>
        </p:txBody>
      </p:sp>
      <p:sp>
        <p:nvSpPr>
          <p:cNvPr id="20" name="正方形/長方形 19"/>
          <p:cNvSpPr/>
          <p:nvPr/>
        </p:nvSpPr>
        <p:spPr>
          <a:xfrm>
            <a:off x="704562" y="7752004"/>
            <a:ext cx="314121" cy="4385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250" b="1" dirty="0"/>
              <a:t>I</a:t>
            </a:r>
            <a:endParaRPr lang="ja-JP" altLang="en-US" sz="2250" b="1" dirty="0"/>
          </a:p>
        </p:txBody>
      </p:sp>
      <p:sp>
        <p:nvSpPr>
          <p:cNvPr id="66" name="正方形/長方形 65"/>
          <p:cNvSpPr/>
          <p:nvPr/>
        </p:nvSpPr>
        <p:spPr>
          <a:xfrm>
            <a:off x="3580562" y="7752004"/>
            <a:ext cx="314121" cy="4385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250" b="1" dirty="0"/>
              <a:t>J</a:t>
            </a:r>
            <a:endParaRPr lang="ja-JP" altLang="en-US" sz="2250" b="1" dirty="0"/>
          </a:p>
        </p:txBody>
      </p:sp>
    </p:spTree>
    <p:extLst>
      <p:ext uri="{BB962C8B-B14F-4D97-AF65-F5344CB8AC3E}">
        <p14:creationId xmlns:p14="http://schemas.microsoft.com/office/powerpoint/2010/main" val="3201080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82</Words>
  <Application>Microsoft Office PowerPoint</Application>
  <PresentationFormat>A4 210 x 297 mm</PresentationFormat>
  <Paragraphs>2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>筑波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田 道夫</dc:creator>
  <cp:lastModifiedBy>道夫</cp:lastModifiedBy>
  <cp:revision>2</cp:revision>
  <dcterms:created xsi:type="dcterms:W3CDTF">2020-09-04T09:04:57Z</dcterms:created>
  <dcterms:modified xsi:type="dcterms:W3CDTF">2020-10-21T14:48:28Z</dcterms:modified>
</cp:coreProperties>
</file>